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7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4" d="100"/>
          <a:sy n="74" d="100"/>
        </p:scale>
        <p:origin x="57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C0BF230-540A-4B7D-AE3A-AAB10C1E7193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BA04CDE-CFA5-4715-A266-875FA1FE78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16098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Supplementary</a:t>
            </a:r>
            <a:r>
              <a:rPr lang="en-US" baseline="0" dirty="0" smtClean="0"/>
              <a:t> Figure 1. Representative plots of baseline Penh values measured twice (one week apart)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C24DA28-3FEE-A647-8B34-4045B99FD97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679491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57AEF-12A2-45FE-9006-C5F2CBB84B25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0362F9-9918-4DB2-9A22-C742B8860D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46772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57AEF-12A2-45FE-9006-C5F2CBB84B25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0362F9-9918-4DB2-9A22-C742B8860D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39918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57AEF-12A2-45FE-9006-C5F2CBB84B25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0362F9-9918-4DB2-9A22-C742B8860D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87089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57AEF-12A2-45FE-9006-C5F2CBB84B25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0362F9-9918-4DB2-9A22-C742B8860D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22191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57AEF-12A2-45FE-9006-C5F2CBB84B25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0362F9-9918-4DB2-9A22-C742B8860D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0223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57AEF-12A2-45FE-9006-C5F2CBB84B25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0362F9-9918-4DB2-9A22-C742B8860D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05805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57AEF-12A2-45FE-9006-C5F2CBB84B25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0362F9-9918-4DB2-9A22-C742B8860D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31996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57AEF-12A2-45FE-9006-C5F2CBB84B25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0362F9-9918-4DB2-9A22-C742B8860D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82607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57AEF-12A2-45FE-9006-C5F2CBB84B25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0362F9-9918-4DB2-9A22-C742B8860D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34861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57AEF-12A2-45FE-9006-C5F2CBB84B25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0362F9-9918-4DB2-9A22-C742B8860D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63335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57AEF-12A2-45FE-9006-C5F2CBB84B25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0362F9-9918-4DB2-9A22-C742B8860D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58079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857AEF-12A2-45FE-9006-C5F2CBB84B25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0362F9-9918-4DB2-9A22-C742B8860D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85322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728831" y="68267"/>
            <a:ext cx="11854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/>
                <a:cs typeface="Arial"/>
              </a:rPr>
              <a:t>Figure S1</a:t>
            </a:r>
            <a:endParaRPr lang="en-US" dirty="0">
              <a:latin typeface="Arial"/>
              <a:cs typeface="Arial"/>
            </a:endParaRPr>
          </a:p>
        </p:txBody>
      </p:sp>
      <p:sp>
        <p:nvSpPr>
          <p:cNvPr id="5" name="TextBox 4"/>
          <p:cNvSpPr txBox="1"/>
          <p:nvPr/>
        </p:nvSpPr>
        <p:spPr>
          <a:xfrm rot="16200000">
            <a:off x="1502174" y="3231249"/>
            <a:ext cx="723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/>
                <a:cs typeface="Arial"/>
              </a:rPr>
              <a:t>Penh</a:t>
            </a:r>
            <a:endParaRPr lang="en-US" dirty="0">
              <a:latin typeface="Arial"/>
              <a:cs typeface="Arial"/>
            </a:endParaRPr>
          </a:p>
        </p:txBody>
      </p:sp>
      <p:grpSp>
        <p:nvGrpSpPr>
          <p:cNvPr id="14" name="Group 13"/>
          <p:cNvGrpSpPr/>
          <p:nvPr/>
        </p:nvGrpSpPr>
        <p:grpSpPr>
          <a:xfrm>
            <a:off x="4749572" y="6421628"/>
            <a:ext cx="2473475" cy="246221"/>
            <a:chOff x="3409952" y="6332637"/>
            <a:chExt cx="2473475" cy="246221"/>
          </a:xfrm>
        </p:grpSpPr>
        <p:cxnSp>
          <p:nvCxnSpPr>
            <p:cNvPr id="7" name="Straight Connector 6"/>
            <p:cNvCxnSpPr/>
            <p:nvPr/>
          </p:nvCxnSpPr>
          <p:spPr>
            <a:xfrm flipV="1">
              <a:off x="4763348" y="6455747"/>
              <a:ext cx="365760" cy="0"/>
            </a:xfrm>
            <a:prstGeom prst="line">
              <a:avLst/>
            </a:prstGeom>
            <a:ln w="12700" cmpd="sng">
              <a:solidFill>
                <a:srgbClr val="FF0000"/>
              </a:solidFill>
              <a:prstDash val="soli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/>
            <p:cNvCxnSpPr/>
            <p:nvPr/>
          </p:nvCxnSpPr>
          <p:spPr>
            <a:xfrm flipV="1">
              <a:off x="3409952" y="6455747"/>
              <a:ext cx="365760" cy="0"/>
            </a:xfrm>
            <a:prstGeom prst="line">
              <a:avLst/>
            </a:prstGeom>
            <a:ln w="12700" cmpd="sng">
              <a:solidFill>
                <a:srgbClr val="0000FF"/>
              </a:solidFill>
              <a:prstDash val="soli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8"/>
            <p:cNvSpPr txBox="1"/>
            <p:nvPr/>
          </p:nvSpPr>
          <p:spPr>
            <a:xfrm>
              <a:off x="3762163" y="6332637"/>
              <a:ext cx="7955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/>
                  <a:cs typeface="Arial"/>
                </a:rPr>
                <a:t>Baseline-1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5087902" y="6332637"/>
              <a:ext cx="7955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/>
                  <a:cs typeface="Arial"/>
                </a:rPr>
                <a:t>Baseline-2</a:t>
              </a:r>
            </a:p>
          </p:txBody>
        </p:sp>
      </p:grpSp>
      <p:sp>
        <p:nvSpPr>
          <p:cNvPr id="13" name="TextBox 12"/>
          <p:cNvSpPr txBox="1"/>
          <p:nvPr/>
        </p:nvSpPr>
        <p:spPr>
          <a:xfrm>
            <a:off x="4784334" y="6072849"/>
            <a:ext cx="24039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>
                <a:latin typeface="Arial"/>
                <a:cs typeface="Arial"/>
              </a:rPr>
              <a:t>Methacholine</a:t>
            </a:r>
            <a:r>
              <a:rPr lang="en-US" dirty="0">
                <a:latin typeface="Arial"/>
                <a:cs typeface="Arial"/>
              </a:rPr>
              <a:t> (mg/ml)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12" name="Picture 11" descr="FigS1_qfitplot.pdf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63022" y="406400"/>
            <a:ext cx="7858125" cy="5715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445980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288275" y="696036"/>
            <a:ext cx="8106770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Figure S1. Example Penh data. Penh data from two baseline measurements, taken one week apart, for 16 </a:t>
            </a:r>
            <a:r>
              <a:rPr lang="en-US" dirty="0" err="1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preCC</a:t>
            </a:r>
            <a:r>
              <a:rPr lang="en-US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mice are shown. The mean values of Penh (per dose of methacholine) were used in subsequent analyses.</a:t>
            </a:r>
          </a:p>
        </p:txBody>
      </p:sp>
    </p:spTree>
    <p:extLst>
      <p:ext uri="{BB962C8B-B14F-4D97-AF65-F5344CB8AC3E}">
        <p14:creationId xmlns:p14="http://schemas.microsoft.com/office/powerpoint/2010/main" val="17751330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0</Words>
  <Application>Microsoft Office PowerPoint</Application>
  <PresentationFormat>Widescreen</PresentationFormat>
  <Paragraphs>8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MS Mincho</vt:lpstr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ah Wolper</dc:creator>
  <cp:lastModifiedBy>Sarah Wolper</cp:lastModifiedBy>
  <cp:revision>1</cp:revision>
  <dcterms:created xsi:type="dcterms:W3CDTF">2016-07-20T19:32:53Z</dcterms:created>
  <dcterms:modified xsi:type="dcterms:W3CDTF">2016-07-20T19:33:05Z</dcterms:modified>
</cp:coreProperties>
</file>